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theme/themeOverride3.xml" ContentType="application/vnd.openxmlformats-officedocument.themeOverrid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theme/themeOverride4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0" r:id="rId2"/>
  </p:sldIdLst>
  <p:sldSz cx="12192000" cy="6858000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9999FF"/>
    <a:srgbClr val="0000FF"/>
    <a:srgbClr val="FF33CC"/>
    <a:srgbClr val="FFC000"/>
    <a:srgbClr val="FFCC99"/>
    <a:srgbClr val="00CCFF"/>
    <a:srgbClr val="6699FF"/>
    <a:srgbClr val="6666FF"/>
    <a:srgbClr val="99CCFF"/>
    <a:srgbClr val="CC99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629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82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oleObject" Target="../embeddings/oleObject1.bin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oleObject" Target="../embeddings/oleObject2.bin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3.xml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oleObject" Target="file:///C:\Users\CASE\Desktop\JJD%20Lab%202022\Projects\Research\Additional%20Experiments\B3Z%20Killing%20Assay\11-11-2022%20B3Z%20Killing%20Assay\11-11-2022%20B3Z%20Killing%20Assay.xlsx" TargetMode="Externa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4.xml"/><Relationship Id="rId2" Type="http://schemas.microsoft.com/office/2011/relationships/chartColorStyle" Target="colors4.xml"/><Relationship Id="rId1" Type="http://schemas.microsoft.com/office/2011/relationships/chartStyle" Target="style4.xml"/><Relationship Id="rId4" Type="http://schemas.openxmlformats.org/officeDocument/2006/relationships/oleObject" Target="file:///C:\Users\CASE\Desktop\JJD%20Lab%202022\Projects\Research\Additional%20Experiments\B3Z%20Killing%20Assay\11-11-2022%20B3Z%20Killing%20Assay\11-11-2022%20B3Z%20Killing%20Assay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22622604146577779"/>
          <c:y val="8.9131333699346046E-2"/>
          <c:w val="0.68600020325096989"/>
          <c:h val="0.60101945460260453"/>
        </c:manualLayout>
      </c:layout>
      <c:barChart>
        <c:barDir val="col"/>
        <c:grouping val="clustered"/>
        <c:varyColors val="0"/>
        <c:ser>
          <c:idx val="1"/>
          <c:order val="0"/>
          <c:tx>
            <c:v>Control</c:v>
          </c:tx>
          <c:spPr>
            <a:solidFill>
              <a:srgbClr val="00B050"/>
            </a:solidFill>
            <a:ln>
              <a:solidFill>
                <a:srgbClr val="00B05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N$24:$N$38</c:f>
                <c:numCache>
                  <c:formatCode>General</c:formatCode>
                  <c:ptCount val="15"/>
                  <c:pt idx="0">
                    <c:v>0.56499308624087985</c:v>
                  </c:pt>
                  <c:pt idx="1">
                    <c:v>0.56499308624087985</c:v>
                  </c:pt>
                  <c:pt idx="2">
                    <c:v>0.56499308624087996</c:v>
                  </c:pt>
                  <c:pt idx="3">
                    <c:v>0.56499308624087996</c:v>
                  </c:pt>
                  <c:pt idx="4">
                    <c:v>0.56499308624087996</c:v>
                  </c:pt>
                  <c:pt idx="5">
                    <c:v>0.56499308624087996</c:v>
                  </c:pt>
                  <c:pt idx="6">
                    <c:v>0.56499308624087996</c:v>
                  </c:pt>
                  <c:pt idx="7">
                    <c:v>0.56499308624087996</c:v>
                  </c:pt>
                  <c:pt idx="8">
                    <c:v>0.56499308624087996</c:v>
                  </c:pt>
                  <c:pt idx="9">
                    <c:v>0.56499308624087996</c:v>
                  </c:pt>
                  <c:pt idx="10">
                    <c:v>0.56499308624087996</c:v>
                  </c:pt>
                  <c:pt idx="11">
                    <c:v>0.56499308624087996</c:v>
                  </c:pt>
                  <c:pt idx="12">
                    <c:v>0.56499308624087996</c:v>
                  </c:pt>
                  <c:pt idx="13">
                    <c:v>0.56499308624087996</c:v>
                  </c:pt>
                  <c:pt idx="14">
                    <c:v>0.56499308624087996</c:v>
                  </c:pt>
                </c:numCache>
              </c:numRef>
            </c:plus>
            <c:minus>
              <c:numRef>
                <c:f>Sheet1!$N$24:$N$38</c:f>
                <c:numCache>
                  <c:formatCode>General</c:formatCode>
                  <c:ptCount val="15"/>
                  <c:pt idx="0">
                    <c:v>0.56499308624087985</c:v>
                  </c:pt>
                  <c:pt idx="1">
                    <c:v>0.56499308624087985</c:v>
                  </c:pt>
                  <c:pt idx="2">
                    <c:v>0.56499308624087996</c:v>
                  </c:pt>
                  <c:pt idx="3">
                    <c:v>0.56499308624087996</c:v>
                  </c:pt>
                  <c:pt idx="4">
                    <c:v>0.56499308624087996</c:v>
                  </c:pt>
                  <c:pt idx="5">
                    <c:v>0.56499308624087996</c:v>
                  </c:pt>
                  <c:pt idx="6">
                    <c:v>0.56499308624087996</c:v>
                  </c:pt>
                  <c:pt idx="7">
                    <c:v>0.56499308624087996</c:v>
                  </c:pt>
                  <c:pt idx="8">
                    <c:v>0.56499308624087996</c:v>
                  </c:pt>
                  <c:pt idx="9">
                    <c:v>0.56499308624087996</c:v>
                  </c:pt>
                  <c:pt idx="10">
                    <c:v>0.56499308624087996</c:v>
                  </c:pt>
                  <c:pt idx="11">
                    <c:v>0.56499308624087996</c:v>
                  </c:pt>
                  <c:pt idx="12">
                    <c:v>0.56499308624087996</c:v>
                  </c:pt>
                  <c:pt idx="13">
                    <c:v>0.56499308624087996</c:v>
                  </c:pt>
                  <c:pt idx="14">
                    <c:v>0.56499308624087996</c:v>
                  </c:pt>
                </c:numCache>
              </c:numRef>
            </c:minus>
            <c:spPr>
              <a:noFill/>
              <a:ln w="1587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strRef>
              <c:f>Sheet1!$C$24:$C$38</c:f>
              <c:strCache>
                <c:ptCount val="15"/>
                <c:pt idx="0">
                  <c:v>ACY 1215</c:v>
                </c:pt>
                <c:pt idx="1">
                  <c:v>Dipyridamole</c:v>
                </c:pt>
                <c:pt idx="2">
                  <c:v>Salinomycin</c:v>
                </c:pt>
                <c:pt idx="3">
                  <c:v>Rapamycin</c:v>
                </c:pt>
                <c:pt idx="4">
                  <c:v>Abiraterone</c:v>
                </c:pt>
                <c:pt idx="5">
                  <c:v>Tubastatin A</c:v>
                </c:pt>
                <c:pt idx="6">
                  <c:v>DC661</c:v>
                </c:pt>
                <c:pt idx="7">
                  <c:v>Sclareol</c:v>
                </c:pt>
                <c:pt idx="8">
                  <c:v>1,10-phenanthroline</c:v>
                </c:pt>
                <c:pt idx="9">
                  <c:v>Riluzole</c:v>
                </c:pt>
                <c:pt idx="10">
                  <c:v>Betulinic acid</c:v>
                </c:pt>
                <c:pt idx="11">
                  <c:v>Rolipram</c:v>
                </c:pt>
                <c:pt idx="12">
                  <c:v>HCQ</c:v>
                </c:pt>
                <c:pt idx="13">
                  <c:v>DMNQ</c:v>
                </c:pt>
                <c:pt idx="14">
                  <c:v>Stained Control</c:v>
                </c:pt>
              </c:strCache>
            </c:strRef>
          </c:cat>
          <c:val>
            <c:numRef>
              <c:f>Sheet1!$L$24:$L$38</c:f>
              <c:numCache>
                <c:formatCode>General</c:formatCode>
                <c:ptCount val="15"/>
                <c:pt idx="0">
                  <c:v>8.5675000000000008</c:v>
                </c:pt>
                <c:pt idx="1">
                  <c:v>8.5675000000000008</c:v>
                </c:pt>
                <c:pt idx="2">
                  <c:v>8.5675000000000008</c:v>
                </c:pt>
                <c:pt idx="3">
                  <c:v>8.5675000000000008</c:v>
                </c:pt>
                <c:pt idx="4">
                  <c:v>8.5675000000000008</c:v>
                </c:pt>
                <c:pt idx="5">
                  <c:v>8.5675000000000008</c:v>
                </c:pt>
                <c:pt idx="6">
                  <c:v>8.5675000000000008</c:v>
                </c:pt>
                <c:pt idx="7">
                  <c:v>8.5675000000000008</c:v>
                </c:pt>
                <c:pt idx="8">
                  <c:v>8.5675000000000008</c:v>
                </c:pt>
                <c:pt idx="9">
                  <c:v>8.5675000000000008</c:v>
                </c:pt>
                <c:pt idx="10">
                  <c:v>8.5675000000000008</c:v>
                </c:pt>
                <c:pt idx="11">
                  <c:v>8.5675000000000008</c:v>
                </c:pt>
                <c:pt idx="12">
                  <c:v>8.5675000000000008</c:v>
                </c:pt>
                <c:pt idx="13">
                  <c:v>8.5675000000000008</c:v>
                </c:pt>
                <c:pt idx="14">
                  <c:v>8.567500000000000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FAB-42B7-81BF-254650A3A3A2}"/>
            </c:ext>
          </c:extLst>
        </c:ser>
        <c:ser>
          <c:idx val="0"/>
          <c:order val="1"/>
          <c:tx>
            <c:v>Series1</c:v>
          </c:tx>
          <c:spPr>
            <a:solidFill>
              <a:srgbClr val="FF0000"/>
            </a:solidFill>
            <a:ln>
              <a:solidFill>
                <a:srgbClr val="FF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J$24:$J$38</c:f>
                <c:numCache>
                  <c:formatCode>General</c:formatCode>
                  <c:ptCount val="15"/>
                  <c:pt idx="0">
                    <c:v>0.41948443058115992</c:v>
                  </c:pt>
                  <c:pt idx="1">
                    <c:v>0.30898017735770678</c:v>
                  </c:pt>
                  <c:pt idx="2">
                    <c:v>2.3692044418960561</c:v>
                  </c:pt>
                  <c:pt idx="3">
                    <c:v>0.50906777544841797</c:v>
                  </c:pt>
                  <c:pt idx="4">
                    <c:v>6.976149845485459E-2</c:v>
                  </c:pt>
                  <c:pt idx="5">
                    <c:v>0.31395411687060265</c:v>
                  </c:pt>
                  <c:pt idx="6">
                    <c:v>0.33797874138713152</c:v>
                  </c:pt>
                  <c:pt idx="7">
                    <c:v>0.36464880364537067</c:v>
                  </c:pt>
                  <c:pt idx="8">
                    <c:v>0.62242060329604076</c:v>
                  </c:pt>
                  <c:pt idx="9">
                    <c:v>0.93030572931698086</c:v>
                  </c:pt>
                  <c:pt idx="10">
                    <c:v>2.5060186925679551</c:v>
                  </c:pt>
                  <c:pt idx="11">
                    <c:v>3.0950290285391509</c:v>
                  </c:pt>
                  <c:pt idx="12">
                    <c:v>1.574321282330897</c:v>
                  </c:pt>
                  <c:pt idx="13">
                    <c:v>1.833541654830884</c:v>
                  </c:pt>
                  <c:pt idx="14">
                    <c:v>0.56499308624087985</c:v>
                  </c:pt>
                </c:numCache>
              </c:numRef>
            </c:plus>
            <c:minus>
              <c:numRef>
                <c:f>Sheet1!$J$24:$J$38</c:f>
                <c:numCache>
                  <c:formatCode>General</c:formatCode>
                  <c:ptCount val="15"/>
                  <c:pt idx="0">
                    <c:v>0.41948443058115992</c:v>
                  </c:pt>
                  <c:pt idx="1">
                    <c:v>0.30898017735770678</c:v>
                  </c:pt>
                  <c:pt idx="2">
                    <c:v>2.3692044418960561</c:v>
                  </c:pt>
                  <c:pt idx="3">
                    <c:v>0.50906777544841797</c:v>
                  </c:pt>
                  <c:pt idx="4">
                    <c:v>6.976149845485459E-2</c:v>
                  </c:pt>
                  <c:pt idx="5">
                    <c:v>0.31395411687060265</c:v>
                  </c:pt>
                  <c:pt idx="6">
                    <c:v>0.33797874138713152</c:v>
                  </c:pt>
                  <c:pt idx="7">
                    <c:v>0.36464880364537067</c:v>
                  </c:pt>
                  <c:pt idx="8">
                    <c:v>0.62242060329604076</c:v>
                  </c:pt>
                  <c:pt idx="9">
                    <c:v>0.93030572931698086</c:v>
                  </c:pt>
                  <c:pt idx="10">
                    <c:v>2.5060186925679551</c:v>
                  </c:pt>
                  <c:pt idx="11">
                    <c:v>3.0950290285391509</c:v>
                  </c:pt>
                  <c:pt idx="12">
                    <c:v>1.574321282330897</c:v>
                  </c:pt>
                  <c:pt idx="13">
                    <c:v>1.833541654830884</c:v>
                  </c:pt>
                  <c:pt idx="14">
                    <c:v>0.56499308624087985</c:v>
                  </c:pt>
                </c:numCache>
              </c:numRef>
            </c:minus>
            <c:spPr>
              <a:noFill/>
              <a:ln w="1587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strRef>
              <c:f>Sheet1!$C$24:$C$38</c:f>
              <c:strCache>
                <c:ptCount val="15"/>
                <c:pt idx="0">
                  <c:v>ACY 1215</c:v>
                </c:pt>
                <c:pt idx="1">
                  <c:v>Dipyridamole</c:v>
                </c:pt>
                <c:pt idx="2">
                  <c:v>Salinomycin</c:v>
                </c:pt>
                <c:pt idx="3">
                  <c:v>Rapamycin</c:v>
                </c:pt>
                <c:pt idx="4">
                  <c:v>Abiraterone</c:v>
                </c:pt>
                <c:pt idx="5">
                  <c:v>Tubastatin A</c:v>
                </c:pt>
                <c:pt idx="6">
                  <c:v>DC661</c:v>
                </c:pt>
                <c:pt idx="7">
                  <c:v>Sclareol</c:v>
                </c:pt>
                <c:pt idx="8">
                  <c:v>1,10-phenanthroline</c:v>
                </c:pt>
                <c:pt idx="9">
                  <c:v>Riluzole</c:v>
                </c:pt>
                <c:pt idx="10">
                  <c:v>Betulinic acid</c:v>
                </c:pt>
                <c:pt idx="11">
                  <c:v>Rolipram</c:v>
                </c:pt>
                <c:pt idx="12">
                  <c:v>HCQ</c:v>
                </c:pt>
                <c:pt idx="13">
                  <c:v>DMNQ</c:v>
                </c:pt>
                <c:pt idx="14">
                  <c:v>Stained Control</c:v>
                </c:pt>
              </c:strCache>
            </c:strRef>
          </c:cat>
          <c:val>
            <c:numRef>
              <c:f>Sheet1!$H$24:$H$38</c:f>
              <c:numCache>
                <c:formatCode>General</c:formatCode>
                <c:ptCount val="15"/>
                <c:pt idx="0">
                  <c:v>10.172499999999999</c:v>
                </c:pt>
                <c:pt idx="1">
                  <c:v>12.125</c:v>
                </c:pt>
                <c:pt idx="2">
                  <c:v>8.6024999999999991</c:v>
                </c:pt>
                <c:pt idx="3">
                  <c:v>5.5</c:v>
                </c:pt>
                <c:pt idx="4">
                  <c:v>7.98</c:v>
                </c:pt>
                <c:pt idx="5">
                  <c:v>10.0275</c:v>
                </c:pt>
                <c:pt idx="6">
                  <c:v>5.9333333333333336</c:v>
                </c:pt>
                <c:pt idx="7">
                  <c:v>13.475</c:v>
                </c:pt>
                <c:pt idx="8">
                  <c:v>14.566666666666668</c:v>
                </c:pt>
                <c:pt idx="9">
                  <c:v>19.425000000000001</c:v>
                </c:pt>
                <c:pt idx="10">
                  <c:v>6.3224999999999998</c:v>
                </c:pt>
                <c:pt idx="11">
                  <c:v>6.0875000000000004</c:v>
                </c:pt>
                <c:pt idx="12">
                  <c:v>7.1499999999999995</c:v>
                </c:pt>
                <c:pt idx="13">
                  <c:v>15.850000000000001</c:v>
                </c:pt>
                <c:pt idx="14">
                  <c:v>8.567500000000000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FAB-42B7-81BF-254650A3A3A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607278200"/>
        <c:axId val="1131435656"/>
      </c:barChart>
      <c:catAx>
        <c:axId val="607278200"/>
        <c:scaling>
          <c:orientation val="minMax"/>
        </c:scaling>
        <c:delete val="0"/>
        <c:axPos val="b"/>
        <c:numFmt formatCode="General" sourceLinked="1"/>
        <c:majorTickMark val="none"/>
        <c:minorTickMark val="out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131435656"/>
        <c:crosses val="autoZero"/>
        <c:auto val="1"/>
        <c:lblAlgn val="ctr"/>
        <c:lblOffset val="100"/>
        <c:tickMarkSkip val="1"/>
        <c:noMultiLvlLbl val="0"/>
      </c:catAx>
      <c:valAx>
        <c:axId val="1131435656"/>
        <c:scaling>
          <c:orientation val="minMax"/>
          <c:max val="40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200" b="1"/>
                  <a:t>CD8</a:t>
                </a:r>
                <a:r>
                  <a:rPr lang="en-US" sz="1200" b="1" baseline="30000"/>
                  <a:t>-</a:t>
                </a:r>
                <a:r>
                  <a:rPr lang="en-US" sz="1200" b="1"/>
                  <a:t>, Annexin V</a:t>
                </a:r>
                <a:r>
                  <a:rPr lang="en-US" sz="1200" b="1" baseline="30000"/>
                  <a:t>+</a:t>
                </a:r>
                <a:r>
                  <a:rPr lang="en-US" sz="1200" b="1"/>
                  <a:t>,</a:t>
                </a:r>
                <a:r>
                  <a:rPr lang="en-US" sz="1200" b="1" baseline="0"/>
                  <a:t> PI</a:t>
                </a:r>
                <a:r>
                  <a:rPr lang="en-US" sz="1200" b="1" baseline="30000"/>
                  <a:t>+</a:t>
                </a:r>
                <a:r>
                  <a:rPr lang="en-US" sz="1200" b="1" baseline="0"/>
                  <a:t>, %</a:t>
                </a:r>
                <a:endParaRPr lang="en-US" sz="1200" b="1"/>
              </a:p>
            </c:rich>
          </c:tx>
          <c:layout>
            <c:manualLayout>
              <c:xMode val="edge"/>
              <c:yMode val="edge"/>
              <c:x val="0.15317400477253773"/>
              <c:y val="7.1976804523731744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07278200"/>
        <c:crosses val="autoZero"/>
        <c:crossBetween val="between"/>
        <c:majorUnit val="1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680" b="0" i="0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200" b="1"/>
              <a:t>E.G7-Ova</a:t>
            </a:r>
          </a:p>
        </c:rich>
      </c:tx>
      <c:layout>
        <c:manualLayout>
          <c:xMode val="edge"/>
          <c:yMode val="edge"/>
          <c:x val="0.36401468206000753"/>
          <c:y val="0.1187534998824533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80" b="0" i="0" u="none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21700363464068179"/>
          <c:y val="0.16246767026462119"/>
          <c:w val="0.65759798488613119"/>
          <c:h val="0.5188471303651908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Co-Culture'!$E$3</c:f>
              <c:strCache>
                <c:ptCount val="1"/>
                <c:pt idx="0">
                  <c:v>CD8-, Annexin V+, PI+, %</c:v>
                </c:pt>
              </c:strCache>
            </c:strRef>
          </c:tx>
          <c:spPr>
            <a:solidFill>
              <a:srgbClr val="FF0000"/>
            </a:solidFill>
            <a:ln>
              <a:solidFill>
                <a:srgbClr val="FF0000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B050"/>
              </a:solidFill>
              <a:ln>
                <a:solidFill>
                  <a:srgbClr val="00B05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CB6E-4F9C-9539-855C3DAD0054}"/>
              </c:ext>
            </c:extLst>
          </c:dPt>
          <c:errBars>
            <c:errBarType val="both"/>
            <c:errValType val="cust"/>
            <c:noEndCap val="0"/>
            <c:plus>
              <c:numRef>
                <c:f>'E.G7-Ova Only'!$G$4:$G$9</c:f>
                <c:numCache>
                  <c:formatCode>General</c:formatCode>
                  <c:ptCount val="6"/>
                  <c:pt idx="0">
                    <c:v>0.45797865064262977</c:v>
                  </c:pt>
                  <c:pt idx="1">
                    <c:v>0.71517674583125168</c:v>
                  </c:pt>
                  <c:pt idx="2">
                    <c:v>2.0897926531915405</c:v>
                  </c:pt>
                  <c:pt idx="3">
                    <c:v>0.48521472909767832</c:v>
                  </c:pt>
                  <c:pt idx="4">
                    <c:v>1.959101267872027</c:v>
                  </c:pt>
                  <c:pt idx="5">
                    <c:v>1.3612126946219696</c:v>
                  </c:pt>
                </c:numCache>
              </c:numRef>
            </c:plus>
            <c:minus>
              <c:numRef>
                <c:f>'E.G7-Ova Only'!$G$4:$G$9</c:f>
                <c:numCache>
                  <c:formatCode>General</c:formatCode>
                  <c:ptCount val="6"/>
                  <c:pt idx="0">
                    <c:v>0.45797865064262977</c:v>
                  </c:pt>
                  <c:pt idx="1">
                    <c:v>0.71517674583125168</c:v>
                  </c:pt>
                  <c:pt idx="2">
                    <c:v>2.0897926531915405</c:v>
                  </c:pt>
                  <c:pt idx="3">
                    <c:v>0.48521472909767832</c:v>
                  </c:pt>
                  <c:pt idx="4">
                    <c:v>1.959101267872027</c:v>
                  </c:pt>
                  <c:pt idx="5">
                    <c:v>1.3612126946219696</c:v>
                  </c:pt>
                </c:numCache>
              </c:numRef>
            </c:minus>
            <c:spPr>
              <a:noFill/>
              <a:ln w="1587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strRef>
              <c:f>'Co-Culture'!$A$4:$A$9</c:f>
              <c:strCache>
                <c:ptCount val="6"/>
                <c:pt idx="0">
                  <c:v>Untreated</c:v>
                </c:pt>
                <c:pt idx="1">
                  <c:v>Tubastatin-A</c:v>
                </c:pt>
                <c:pt idx="2">
                  <c:v>WT-161</c:v>
                </c:pt>
                <c:pt idx="3">
                  <c:v>ACY-1215</c:v>
                </c:pt>
                <c:pt idx="4">
                  <c:v>ACY-738</c:v>
                </c:pt>
                <c:pt idx="5">
                  <c:v>ACY-241</c:v>
                </c:pt>
              </c:strCache>
            </c:strRef>
          </c:cat>
          <c:val>
            <c:numRef>
              <c:f>'E.G7-Ova Only'!$E$4:$E$9</c:f>
              <c:numCache>
                <c:formatCode>General</c:formatCode>
                <c:ptCount val="6"/>
                <c:pt idx="0">
                  <c:v>4.3933333333333335</c:v>
                </c:pt>
                <c:pt idx="1">
                  <c:v>3.8533333333333335</c:v>
                </c:pt>
                <c:pt idx="2">
                  <c:v>6.4499999999999993</c:v>
                </c:pt>
                <c:pt idx="3">
                  <c:v>10.01</c:v>
                </c:pt>
                <c:pt idx="4">
                  <c:v>7.1566666666666663</c:v>
                </c:pt>
                <c:pt idx="5">
                  <c:v>6.489999999999999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CB6E-4F9C-9539-855C3DAD005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0"/>
        <c:axId val="607278200"/>
        <c:axId val="1131435656"/>
      </c:barChart>
      <c:catAx>
        <c:axId val="607278200"/>
        <c:scaling>
          <c:orientation val="minMax"/>
        </c:scaling>
        <c:delete val="0"/>
        <c:axPos val="b"/>
        <c:numFmt formatCode="General" sourceLinked="1"/>
        <c:majorTickMark val="none"/>
        <c:minorTickMark val="out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131435656"/>
        <c:crosses val="autoZero"/>
        <c:auto val="1"/>
        <c:lblAlgn val="ctr"/>
        <c:lblOffset val="100"/>
        <c:tickMarkSkip val="1"/>
        <c:noMultiLvlLbl val="0"/>
      </c:catAx>
      <c:valAx>
        <c:axId val="1131435656"/>
        <c:scaling>
          <c:orientation val="minMax"/>
          <c:max val="40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000" b="1" baseline="0"/>
                  <a:t>CD8-, Annexin V+, PI+, %</a:t>
                </a:r>
              </a:p>
            </c:rich>
          </c:tx>
          <c:layout>
            <c:manualLayout>
              <c:xMode val="edge"/>
              <c:yMode val="edge"/>
              <c:x val="7.1673866260307334E-2"/>
              <c:y val="0.1176634690297272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07278200"/>
        <c:crosses val="autoZero"/>
        <c:crossBetween val="between"/>
        <c:majorUnit val="1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4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680" b="0" i="0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200" b="1"/>
              <a:t>B3Z</a:t>
            </a:r>
          </a:p>
        </c:rich>
      </c:tx>
      <c:layout>
        <c:manualLayout>
          <c:xMode val="edge"/>
          <c:yMode val="edge"/>
          <c:x val="0.473533506619921"/>
          <c:y val="0.1335158478745851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80" b="0" i="0" u="none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22042247758185529"/>
          <c:y val="0.1513960153865512"/>
          <c:w val="0.73933853280216455"/>
          <c:h val="0.5446812393514215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Co-Culture'!$E$3</c:f>
              <c:strCache>
                <c:ptCount val="1"/>
                <c:pt idx="0">
                  <c:v>CD8-, Annexin V+, PI+, %</c:v>
                </c:pt>
              </c:strCache>
            </c:strRef>
          </c:tx>
          <c:spPr>
            <a:solidFill>
              <a:srgbClr val="FF0000"/>
            </a:solidFill>
            <a:ln>
              <a:solidFill>
                <a:srgbClr val="FF0000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B050"/>
              </a:solidFill>
              <a:ln>
                <a:solidFill>
                  <a:srgbClr val="00B05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9DBB-4A30-8F00-529E679F3E75}"/>
              </c:ext>
            </c:extLst>
          </c:dPt>
          <c:errBars>
            <c:errBarType val="both"/>
            <c:errValType val="cust"/>
            <c:noEndCap val="0"/>
            <c:plus>
              <c:numRef>
                <c:f>'B3Z Only'!$G$4:$G$9</c:f>
                <c:numCache>
                  <c:formatCode>General</c:formatCode>
                  <c:ptCount val="6"/>
                  <c:pt idx="0">
                    <c:v>0.2116863507907657</c:v>
                  </c:pt>
                  <c:pt idx="1">
                    <c:v>0.54345601886854122</c:v>
                  </c:pt>
                  <c:pt idx="2">
                    <c:v>0.45522888016176399</c:v>
                  </c:pt>
                  <c:pt idx="3">
                    <c:v>0.22040367006421982</c:v>
                  </c:pt>
                  <c:pt idx="4">
                    <c:v>0.21605040564131742</c:v>
                  </c:pt>
                  <c:pt idx="5">
                    <c:v>0.13892443989449804</c:v>
                  </c:pt>
                </c:numCache>
              </c:numRef>
            </c:plus>
            <c:minus>
              <c:numRef>
                <c:f>'B3Z Only'!$G$4:$G$9</c:f>
                <c:numCache>
                  <c:formatCode>General</c:formatCode>
                  <c:ptCount val="6"/>
                  <c:pt idx="0">
                    <c:v>0.2116863507907657</c:v>
                  </c:pt>
                  <c:pt idx="1">
                    <c:v>0.54345601886854122</c:v>
                  </c:pt>
                  <c:pt idx="2">
                    <c:v>0.45522888016176399</c:v>
                  </c:pt>
                  <c:pt idx="3">
                    <c:v>0.22040367006421982</c:v>
                  </c:pt>
                  <c:pt idx="4">
                    <c:v>0.21605040564131742</c:v>
                  </c:pt>
                  <c:pt idx="5">
                    <c:v>0.13892443989449804</c:v>
                  </c:pt>
                </c:numCache>
              </c:numRef>
            </c:minus>
            <c:spPr>
              <a:noFill/>
              <a:ln w="1587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strRef>
              <c:f>'Co-Culture'!$A$4:$A$9</c:f>
              <c:strCache>
                <c:ptCount val="6"/>
                <c:pt idx="0">
                  <c:v>Untreated</c:v>
                </c:pt>
                <c:pt idx="1">
                  <c:v>Tubastatin-A</c:v>
                </c:pt>
                <c:pt idx="2">
                  <c:v>WT-161</c:v>
                </c:pt>
                <c:pt idx="3">
                  <c:v>ACY-1215</c:v>
                </c:pt>
                <c:pt idx="4">
                  <c:v>ACY-738</c:v>
                </c:pt>
                <c:pt idx="5">
                  <c:v>ACY-241</c:v>
                </c:pt>
              </c:strCache>
            </c:strRef>
          </c:cat>
          <c:val>
            <c:numRef>
              <c:f>'B3Z Only'!$E$4:$E$9</c:f>
              <c:numCache>
                <c:formatCode>General</c:formatCode>
                <c:ptCount val="6"/>
                <c:pt idx="0">
                  <c:v>3.1033333333333335</c:v>
                </c:pt>
                <c:pt idx="1">
                  <c:v>10.536666666666667</c:v>
                </c:pt>
                <c:pt idx="2">
                  <c:v>8.4700000000000006</c:v>
                </c:pt>
                <c:pt idx="3">
                  <c:v>2.6633333333333336</c:v>
                </c:pt>
                <c:pt idx="4">
                  <c:v>4.1566666666666663</c:v>
                </c:pt>
                <c:pt idx="5">
                  <c:v>2.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9DBB-4A30-8F00-529E679F3E7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0"/>
        <c:axId val="607278200"/>
        <c:axId val="1131435656"/>
      </c:barChart>
      <c:catAx>
        <c:axId val="607278200"/>
        <c:scaling>
          <c:orientation val="minMax"/>
        </c:scaling>
        <c:delete val="0"/>
        <c:axPos val="b"/>
        <c:numFmt formatCode="General" sourceLinked="1"/>
        <c:majorTickMark val="none"/>
        <c:minorTickMark val="out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131435656"/>
        <c:crosses val="autoZero"/>
        <c:auto val="1"/>
        <c:lblAlgn val="ctr"/>
        <c:lblOffset val="100"/>
        <c:tickMarkSkip val="1"/>
        <c:noMultiLvlLbl val="0"/>
      </c:catAx>
      <c:valAx>
        <c:axId val="1131435656"/>
        <c:scaling>
          <c:orientation val="minMax"/>
          <c:max val="40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000" b="1" baseline="0"/>
                  <a:t>CD8-, Annexin V+, PI+, %</a:t>
                </a:r>
              </a:p>
            </c:rich>
          </c:tx>
          <c:layout>
            <c:manualLayout>
              <c:xMode val="edge"/>
              <c:yMode val="edge"/>
              <c:x val="6.5432825246147353E-2"/>
              <c:y val="0.1065917080356284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07278200"/>
        <c:crosses val="autoZero"/>
        <c:crossBetween val="between"/>
        <c:majorUnit val="1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4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680" b="0" i="0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200" b="1" smtClean="0"/>
              <a:t>E:T 2:1</a:t>
            </a:r>
            <a:endParaRPr lang="en-US" sz="1200" b="1"/>
          </a:p>
        </c:rich>
      </c:tx>
      <c:layout>
        <c:manualLayout>
          <c:xMode val="edge"/>
          <c:yMode val="edge"/>
          <c:x val="0.38860361537674348"/>
          <c:y val="0.1076817701803971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80" b="0" i="0" u="none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8525752462760336"/>
          <c:y val="0.16246767026462119"/>
          <c:w val="0.64551870056686311"/>
          <c:h val="0.5520624662971905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Co-Culture'!$E$3</c:f>
              <c:strCache>
                <c:ptCount val="1"/>
                <c:pt idx="0">
                  <c:v>CD8-, Annexin V+, PI+, %</c:v>
                </c:pt>
              </c:strCache>
            </c:strRef>
          </c:tx>
          <c:spPr>
            <a:solidFill>
              <a:srgbClr val="FF0000"/>
            </a:solidFill>
            <a:ln>
              <a:solidFill>
                <a:srgbClr val="FF0000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B050"/>
              </a:solidFill>
              <a:ln>
                <a:solidFill>
                  <a:srgbClr val="00B05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8035-4E78-A532-1FC843658BFF}"/>
              </c:ext>
            </c:extLst>
          </c:dPt>
          <c:errBars>
            <c:errBarType val="both"/>
            <c:errValType val="cust"/>
            <c:noEndCap val="0"/>
            <c:plus>
              <c:numRef>
                <c:f>'Co-Culture'!$G$4:$G$9</c:f>
                <c:numCache>
                  <c:formatCode>General</c:formatCode>
                  <c:ptCount val="6"/>
                  <c:pt idx="0">
                    <c:v>0.68763685506555383</c:v>
                  </c:pt>
                  <c:pt idx="1">
                    <c:v>3.353108010985232</c:v>
                  </c:pt>
                  <c:pt idx="2">
                    <c:v>0.89690826980491434</c:v>
                  </c:pt>
                  <c:pt idx="3">
                    <c:v>1.244097173768103</c:v>
                  </c:pt>
                  <c:pt idx="4">
                    <c:v>2.0380409983881815</c:v>
                  </c:pt>
                  <c:pt idx="5">
                    <c:v>2.9745942767226463</c:v>
                  </c:pt>
                </c:numCache>
              </c:numRef>
            </c:plus>
            <c:minus>
              <c:numRef>
                <c:f>'Co-Culture'!$G$4:$G$9</c:f>
                <c:numCache>
                  <c:formatCode>General</c:formatCode>
                  <c:ptCount val="6"/>
                  <c:pt idx="0">
                    <c:v>0.68763685506555383</c:v>
                  </c:pt>
                  <c:pt idx="1">
                    <c:v>3.353108010985232</c:v>
                  </c:pt>
                  <c:pt idx="2">
                    <c:v>0.89690826980491434</c:v>
                  </c:pt>
                  <c:pt idx="3">
                    <c:v>1.244097173768103</c:v>
                  </c:pt>
                  <c:pt idx="4">
                    <c:v>2.0380409983881815</c:v>
                  </c:pt>
                  <c:pt idx="5">
                    <c:v>2.9745942767226463</c:v>
                  </c:pt>
                </c:numCache>
              </c:numRef>
            </c:minus>
            <c:spPr>
              <a:noFill/>
              <a:ln w="1587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strRef>
              <c:f>'Co-Culture'!$A$4:$A$9</c:f>
              <c:strCache>
                <c:ptCount val="6"/>
                <c:pt idx="0">
                  <c:v>Untreated</c:v>
                </c:pt>
                <c:pt idx="1">
                  <c:v>Tubastatin-A</c:v>
                </c:pt>
                <c:pt idx="2">
                  <c:v>WT-161</c:v>
                </c:pt>
                <c:pt idx="3">
                  <c:v>ACY-1215</c:v>
                </c:pt>
                <c:pt idx="4">
                  <c:v>ACY-738</c:v>
                </c:pt>
                <c:pt idx="5">
                  <c:v>ACY-241</c:v>
                </c:pt>
              </c:strCache>
            </c:strRef>
          </c:cat>
          <c:val>
            <c:numRef>
              <c:f>'Co-Culture'!$E$4:$E$9</c:f>
              <c:numCache>
                <c:formatCode>General</c:formatCode>
                <c:ptCount val="6"/>
                <c:pt idx="0">
                  <c:v>5.2566666666666668</c:v>
                </c:pt>
                <c:pt idx="1">
                  <c:v>30.100000000000005</c:v>
                </c:pt>
                <c:pt idx="2">
                  <c:v>33.633333333333333</c:v>
                </c:pt>
                <c:pt idx="3">
                  <c:v>33.966666666666661</c:v>
                </c:pt>
                <c:pt idx="4">
                  <c:v>12.783333333333333</c:v>
                </c:pt>
                <c:pt idx="5">
                  <c:v>13.27666666666666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8035-4E78-A532-1FC843658BF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0"/>
        <c:axId val="607278200"/>
        <c:axId val="1131435656"/>
      </c:barChart>
      <c:catAx>
        <c:axId val="607278200"/>
        <c:scaling>
          <c:orientation val="minMax"/>
        </c:scaling>
        <c:delete val="0"/>
        <c:axPos val="b"/>
        <c:numFmt formatCode="General" sourceLinked="1"/>
        <c:majorTickMark val="none"/>
        <c:minorTickMark val="out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131435656"/>
        <c:crosses val="autoZero"/>
        <c:auto val="1"/>
        <c:lblAlgn val="ctr"/>
        <c:lblOffset val="100"/>
        <c:tickMarkSkip val="1"/>
        <c:noMultiLvlLbl val="0"/>
      </c:catAx>
      <c:valAx>
        <c:axId val="1131435656"/>
        <c:scaling>
          <c:orientation val="minMax"/>
          <c:max val="40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000" b="1" baseline="0"/>
                  <a:t>CD8-, Annexin V+, PI+, %</a:t>
                </a:r>
              </a:p>
            </c:rich>
          </c:tx>
          <c:layout>
            <c:manualLayout>
              <c:xMode val="edge"/>
              <c:yMode val="edge"/>
              <c:x val="2.1649643487797712E-2"/>
              <c:y val="0.1767126217530816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07278200"/>
        <c:crosses val="autoZero"/>
        <c:crossBetween val="between"/>
        <c:majorUnit val="1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67D377B7-C823-472C-9E09-6D86554DC02C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17550" y="1162050"/>
            <a:ext cx="5575300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24F9BC96-858B-41C2-877C-3E56BFBCC5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77778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20730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48891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96872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2090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4784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51218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6452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70106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40298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56530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60492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68365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Rectangle 49"/>
          <p:cNvSpPr/>
          <p:nvPr/>
        </p:nvSpPr>
        <p:spPr>
          <a:xfrm>
            <a:off x="451761" y="7440"/>
            <a:ext cx="437187" cy="36526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2" name="Rectangle 111"/>
          <p:cNvSpPr/>
          <p:nvPr/>
        </p:nvSpPr>
        <p:spPr>
          <a:xfrm rot="16200000">
            <a:off x="-729609" y="1399141"/>
            <a:ext cx="197682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just">
              <a:defRPr sz="1200" b="0" i="0" u="none" strike="noStrike" kern="1200" baseline="0">
                <a:solidFill>
                  <a:sysClr val="windowText" lastClr="000000"/>
                </a:solidFill>
                <a:latin typeface="Arial" charset="0"/>
                <a:ea typeface="Arial" charset="0"/>
                <a:cs typeface="Arial" charset="0"/>
              </a:defRPr>
            </a:pPr>
            <a:r>
              <a:rPr lang="en-US" sz="1200" b="1">
                <a:solidFill>
                  <a:sysClr val="windowText" lastClr="000000"/>
                </a:solidFill>
                <a:latin typeface="Arial" charset="0"/>
                <a:ea typeface="Arial" charset="0"/>
                <a:cs typeface="Arial" charset="0"/>
              </a:rPr>
              <a:t>LDH Release, Relative %</a:t>
            </a:r>
          </a:p>
        </p:txBody>
      </p:sp>
      <p:cxnSp>
        <p:nvCxnSpPr>
          <p:cNvPr id="117" name="Straight Connector 116"/>
          <p:cNvCxnSpPr/>
          <p:nvPr/>
        </p:nvCxnSpPr>
        <p:spPr>
          <a:xfrm flipH="1" flipV="1">
            <a:off x="726004" y="499615"/>
            <a:ext cx="6792" cy="239641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7" name="TextBox 126"/>
          <p:cNvSpPr txBox="1"/>
          <p:nvPr/>
        </p:nvSpPr>
        <p:spPr>
          <a:xfrm rot="19521871">
            <a:off x="1871046" y="3031712"/>
            <a:ext cx="9605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>
                <a:latin typeface="Arial" panose="020B0604020202020204" pitchFamily="34" charset="0"/>
                <a:cs typeface="Arial" panose="020B0604020202020204" pitchFamily="34" charset="0"/>
              </a:rPr>
              <a:t>Tubastatin-A</a:t>
            </a:r>
          </a:p>
        </p:txBody>
      </p:sp>
      <p:sp>
        <p:nvSpPr>
          <p:cNvPr id="128" name="TextBox 127"/>
          <p:cNvSpPr txBox="1"/>
          <p:nvPr/>
        </p:nvSpPr>
        <p:spPr>
          <a:xfrm rot="19521871">
            <a:off x="509652" y="2988997"/>
            <a:ext cx="78098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>
                <a:latin typeface="Arial" panose="020B0604020202020204" pitchFamily="34" charset="0"/>
                <a:cs typeface="Arial" panose="020B0604020202020204" pitchFamily="34" charset="0"/>
              </a:rPr>
              <a:t>ACY-1215</a:t>
            </a:r>
          </a:p>
        </p:txBody>
      </p:sp>
      <p:sp>
        <p:nvSpPr>
          <p:cNvPr id="129" name="TextBox 128"/>
          <p:cNvSpPr txBox="1"/>
          <p:nvPr/>
        </p:nvSpPr>
        <p:spPr>
          <a:xfrm rot="19521871">
            <a:off x="4562731" y="2908045"/>
            <a:ext cx="4700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>
                <a:latin typeface="Arial" panose="020B0604020202020204" pitchFamily="34" charset="0"/>
                <a:cs typeface="Arial" panose="020B0604020202020204" pitchFamily="34" charset="0"/>
              </a:rPr>
              <a:t>HCQ</a:t>
            </a:r>
          </a:p>
        </p:txBody>
      </p:sp>
      <p:sp>
        <p:nvSpPr>
          <p:cNvPr id="130" name="TextBox 129"/>
          <p:cNvSpPr txBox="1"/>
          <p:nvPr/>
        </p:nvSpPr>
        <p:spPr>
          <a:xfrm rot="19521871">
            <a:off x="2559977" y="2925183"/>
            <a:ext cx="5822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>
                <a:latin typeface="Arial" panose="020B0604020202020204" pitchFamily="34" charset="0"/>
                <a:cs typeface="Arial" panose="020B0604020202020204" pitchFamily="34" charset="0"/>
              </a:rPr>
              <a:t>DC661</a:t>
            </a:r>
          </a:p>
        </p:txBody>
      </p:sp>
      <p:sp>
        <p:nvSpPr>
          <p:cNvPr id="131" name="TextBox 130"/>
          <p:cNvSpPr txBox="1"/>
          <p:nvPr/>
        </p:nvSpPr>
        <p:spPr>
          <a:xfrm rot="19521871">
            <a:off x="1002274" y="3019747"/>
            <a:ext cx="9364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>
                <a:latin typeface="Arial" panose="020B0604020202020204" pitchFamily="34" charset="0"/>
                <a:cs typeface="Arial" panose="020B0604020202020204" pitchFamily="34" charset="0"/>
              </a:rPr>
              <a:t>Salinomycin</a:t>
            </a:r>
          </a:p>
        </p:txBody>
      </p:sp>
      <p:sp>
        <p:nvSpPr>
          <p:cNvPr id="132" name="TextBox 131"/>
          <p:cNvSpPr txBox="1"/>
          <p:nvPr/>
        </p:nvSpPr>
        <p:spPr>
          <a:xfrm rot="19521871">
            <a:off x="2743713" y="2961326"/>
            <a:ext cx="6799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>
                <a:latin typeface="Arial" panose="020B0604020202020204" pitchFamily="34" charset="0"/>
                <a:cs typeface="Arial" panose="020B0604020202020204" pitchFamily="34" charset="0"/>
              </a:rPr>
              <a:t>Sclareol</a:t>
            </a:r>
          </a:p>
        </p:txBody>
      </p:sp>
      <p:sp>
        <p:nvSpPr>
          <p:cNvPr id="133" name="TextBox 132"/>
          <p:cNvSpPr txBox="1"/>
          <p:nvPr/>
        </p:nvSpPr>
        <p:spPr>
          <a:xfrm rot="19521871">
            <a:off x="1383633" y="2989009"/>
            <a:ext cx="8659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>
                <a:latin typeface="Arial" panose="020B0604020202020204" pitchFamily="34" charset="0"/>
                <a:cs typeface="Arial" panose="020B0604020202020204" pitchFamily="34" charset="0"/>
              </a:rPr>
              <a:t>Rapamycin</a:t>
            </a:r>
          </a:p>
        </p:txBody>
      </p:sp>
      <p:sp>
        <p:nvSpPr>
          <p:cNvPr id="134" name="TextBox 133"/>
          <p:cNvSpPr txBox="1"/>
          <p:nvPr/>
        </p:nvSpPr>
        <p:spPr>
          <a:xfrm rot="19521871">
            <a:off x="3414889" y="2932854"/>
            <a:ext cx="67518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>
                <a:latin typeface="Arial" panose="020B0604020202020204" pitchFamily="34" charset="0"/>
                <a:cs typeface="Arial" panose="020B0604020202020204" pitchFamily="34" charset="0"/>
              </a:rPr>
              <a:t>Riluzole</a:t>
            </a:r>
          </a:p>
        </p:txBody>
      </p:sp>
      <p:sp>
        <p:nvSpPr>
          <p:cNvPr id="135" name="TextBox 134"/>
          <p:cNvSpPr txBox="1"/>
          <p:nvPr/>
        </p:nvSpPr>
        <p:spPr>
          <a:xfrm rot="19521871">
            <a:off x="1681407" y="3025263"/>
            <a:ext cx="9028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>
                <a:latin typeface="Arial" panose="020B0604020202020204" pitchFamily="34" charset="0"/>
                <a:cs typeface="Arial" panose="020B0604020202020204" pitchFamily="34" charset="0"/>
              </a:rPr>
              <a:t>Abiraterone</a:t>
            </a:r>
          </a:p>
        </p:txBody>
      </p:sp>
      <p:sp>
        <p:nvSpPr>
          <p:cNvPr id="136" name="TextBox 135"/>
          <p:cNvSpPr txBox="1"/>
          <p:nvPr/>
        </p:nvSpPr>
        <p:spPr>
          <a:xfrm rot="19521871">
            <a:off x="3673585" y="2941632"/>
            <a:ext cx="7601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>
                <a:latin typeface="Arial" panose="020B0604020202020204" pitchFamily="34" charset="0"/>
                <a:cs typeface="Arial" panose="020B0604020202020204" pitchFamily="34" charset="0"/>
              </a:rPr>
              <a:t>Betulinic </a:t>
            </a:r>
          </a:p>
        </p:txBody>
      </p:sp>
      <p:sp>
        <p:nvSpPr>
          <p:cNvPr id="137" name="TextBox 136"/>
          <p:cNvSpPr txBox="1"/>
          <p:nvPr/>
        </p:nvSpPr>
        <p:spPr>
          <a:xfrm rot="19521871">
            <a:off x="3979712" y="2945223"/>
            <a:ext cx="73930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>
                <a:latin typeface="Arial" panose="020B0604020202020204" pitchFamily="34" charset="0"/>
                <a:cs typeface="Arial" panose="020B0604020202020204" pitchFamily="34" charset="0"/>
              </a:rPr>
              <a:t>Rolipram</a:t>
            </a:r>
          </a:p>
        </p:txBody>
      </p:sp>
      <p:sp>
        <p:nvSpPr>
          <p:cNvPr id="138" name="TextBox 137"/>
          <p:cNvSpPr txBox="1"/>
          <p:nvPr/>
        </p:nvSpPr>
        <p:spPr>
          <a:xfrm rot="19521871">
            <a:off x="656482" y="3041278"/>
            <a:ext cx="99418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>
                <a:latin typeface="Arial" panose="020B0604020202020204" pitchFamily="34" charset="0"/>
                <a:cs typeface="Arial" panose="020B0604020202020204" pitchFamily="34" charset="0"/>
              </a:rPr>
              <a:t>Dipyridamole</a:t>
            </a:r>
          </a:p>
        </p:txBody>
      </p:sp>
      <p:sp>
        <p:nvSpPr>
          <p:cNvPr id="139" name="TextBox 138"/>
          <p:cNvSpPr txBox="1"/>
          <p:nvPr/>
        </p:nvSpPr>
        <p:spPr>
          <a:xfrm rot="19521871">
            <a:off x="4803160" y="2933180"/>
            <a:ext cx="57740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>
                <a:latin typeface="Arial" panose="020B0604020202020204" pitchFamily="34" charset="0"/>
                <a:cs typeface="Arial" panose="020B0604020202020204" pitchFamily="34" charset="0"/>
              </a:rPr>
              <a:t>DMNQ</a:t>
            </a:r>
          </a:p>
        </p:txBody>
      </p:sp>
      <p:sp>
        <p:nvSpPr>
          <p:cNvPr id="140" name="TextBox 139"/>
          <p:cNvSpPr txBox="1"/>
          <p:nvPr/>
        </p:nvSpPr>
        <p:spPr>
          <a:xfrm rot="19521871">
            <a:off x="2980676" y="2971546"/>
            <a:ext cx="78098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>
                <a:latin typeface="Arial" panose="020B0604020202020204" pitchFamily="34" charset="0"/>
                <a:cs typeface="Arial" panose="020B0604020202020204" pitchFamily="34" charset="0"/>
              </a:rPr>
              <a:t>1,10-phen</a:t>
            </a:r>
          </a:p>
        </p:txBody>
      </p:sp>
      <p:sp>
        <p:nvSpPr>
          <p:cNvPr id="141" name="TextBox 140"/>
          <p:cNvSpPr txBox="1"/>
          <p:nvPr/>
        </p:nvSpPr>
        <p:spPr>
          <a:xfrm rot="19521871">
            <a:off x="338400" y="2958695"/>
            <a:ext cx="63030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>
                <a:latin typeface="Arial" panose="020B0604020202020204" pitchFamily="34" charset="0"/>
                <a:cs typeface="Arial" panose="020B0604020202020204" pitchFamily="34" charset="0"/>
              </a:rPr>
              <a:t>Vehicle</a:t>
            </a:r>
          </a:p>
        </p:txBody>
      </p:sp>
      <p:sp>
        <p:nvSpPr>
          <p:cNvPr id="201" name="TextBox 200"/>
          <p:cNvSpPr txBox="1"/>
          <p:nvPr/>
        </p:nvSpPr>
        <p:spPr>
          <a:xfrm>
            <a:off x="1047586" y="829349"/>
            <a:ext cx="7521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EG.7-Ova</a:t>
            </a:r>
          </a:p>
        </p:txBody>
      </p:sp>
      <p:sp>
        <p:nvSpPr>
          <p:cNvPr id="202" name="Rectangle 201"/>
          <p:cNvSpPr/>
          <p:nvPr/>
        </p:nvSpPr>
        <p:spPr>
          <a:xfrm>
            <a:off x="880470" y="1108057"/>
            <a:ext cx="164592" cy="164592"/>
          </a:xfrm>
          <a:prstGeom prst="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endParaRPr lang="en-US"/>
          </a:p>
        </p:txBody>
      </p:sp>
      <p:sp>
        <p:nvSpPr>
          <p:cNvPr id="204" name="TextBox 203"/>
          <p:cNvSpPr txBox="1"/>
          <p:nvPr/>
        </p:nvSpPr>
        <p:spPr>
          <a:xfrm>
            <a:off x="1045556" y="1076071"/>
            <a:ext cx="405280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B3Z cells treated with proteasome activator and co-cultured with E.G7-Ova (E:T ratio 2:1)</a:t>
            </a:r>
          </a:p>
        </p:txBody>
      </p:sp>
      <p:sp>
        <p:nvSpPr>
          <p:cNvPr id="205" name="Rectangle 204"/>
          <p:cNvSpPr/>
          <p:nvPr/>
        </p:nvSpPr>
        <p:spPr>
          <a:xfrm>
            <a:off x="883009" y="860249"/>
            <a:ext cx="158101" cy="163653"/>
          </a:xfrm>
          <a:prstGeom prst="rect">
            <a:avLst/>
          </a:prstGeom>
          <a:solidFill>
            <a:srgbClr val="00B05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endParaRPr lang="en-US"/>
          </a:p>
        </p:txBody>
      </p:sp>
      <p:sp>
        <p:nvSpPr>
          <p:cNvPr id="207" name="Rectangle 206"/>
          <p:cNvSpPr/>
          <p:nvPr/>
        </p:nvSpPr>
        <p:spPr>
          <a:xfrm>
            <a:off x="882021" y="607545"/>
            <a:ext cx="164592" cy="164592"/>
          </a:xfrm>
          <a:prstGeom prst="rect">
            <a:avLst/>
          </a:prstGeom>
          <a:solidFill>
            <a:srgbClr val="7030A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endParaRPr lang="en-US"/>
          </a:p>
        </p:txBody>
      </p:sp>
      <p:sp>
        <p:nvSpPr>
          <p:cNvPr id="208" name="TextBox 207"/>
          <p:cNvSpPr txBox="1"/>
          <p:nvPr/>
        </p:nvSpPr>
        <p:spPr>
          <a:xfrm>
            <a:off x="1056182" y="570687"/>
            <a:ext cx="71045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B3Z cells</a:t>
            </a:r>
          </a:p>
        </p:txBody>
      </p:sp>
      <p:sp>
        <p:nvSpPr>
          <p:cNvPr id="210" name="TextBox 209"/>
          <p:cNvSpPr txBox="1"/>
          <p:nvPr/>
        </p:nvSpPr>
        <p:spPr>
          <a:xfrm>
            <a:off x="408669" y="1832951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n-US" sz="900" b="1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211" name="TextBox 210"/>
          <p:cNvSpPr txBox="1"/>
          <p:nvPr/>
        </p:nvSpPr>
        <p:spPr>
          <a:xfrm>
            <a:off x="391272" y="855372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n-US" sz="900" b="1">
                <a:latin typeface="Arial" panose="020B0604020202020204" pitchFamily="34" charset="0"/>
                <a:cs typeface="Arial" panose="020B0604020202020204" pitchFamily="34" charset="0"/>
              </a:rPr>
              <a:t>200</a:t>
            </a:r>
          </a:p>
        </p:txBody>
      </p:sp>
      <p:sp>
        <p:nvSpPr>
          <p:cNvPr id="213" name="Rectangle 212"/>
          <p:cNvSpPr/>
          <p:nvPr/>
        </p:nvSpPr>
        <p:spPr>
          <a:xfrm>
            <a:off x="762510" y="2605033"/>
            <a:ext cx="128016" cy="270575"/>
          </a:xfrm>
          <a:prstGeom prst="rect">
            <a:avLst/>
          </a:prstGeom>
          <a:solidFill>
            <a:srgbClr val="7030A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endParaRPr lang="en-US"/>
          </a:p>
        </p:txBody>
      </p:sp>
      <p:sp>
        <p:nvSpPr>
          <p:cNvPr id="214" name="Rectangle 213"/>
          <p:cNvSpPr/>
          <p:nvPr/>
        </p:nvSpPr>
        <p:spPr>
          <a:xfrm>
            <a:off x="949706" y="1970017"/>
            <a:ext cx="128016" cy="914400"/>
          </a:xfrm>
          <a:prstGeom prst="rect">
            <a:avLst/>
          </a:prstGeom>
          <a:solidFill>
            <a:srgbClr val="00B05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endParaRPr lang="en-US"/>
          </a:p>
        </p:txBody>
      </p:sp>
      <p:sp>
        <p:nvSpPr>
          <p:cNvPr id="216" name="Rectangle 215"/>
          <p:cNvSpPr/>
          <p:nvPr/>
        </p:nvSpPr>
        <p:spPr>
          <a:xfrm>
            <a:off x="1082802" y="1781618"/>
            <a:ext cx="128016" cy="1097280"/>
          </a:xfrm>
          <a:prstGeom prst="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endParaRPr lang="en-US"/>
          </a:p>
        </p:txBody>
      </p:sp>
      <p:sp>
        <p:nvSpPr>
          <p:cNvPr id="217" name="Rectangle 216"/>
          <p:cNvSpPr/>
          <p:nvPr/>
        </p:nvSpPr>
        <p:spPr>
          <a:xfrm>
            <a:off x="1256773" y="1958499"/>
            <a:ext cx="128016" cy="914400"/>
          </a:xfrm>
          <a:prstGeom prst="rect">
            <a:avLst/>
          </a:prstGeom>
          <a:solidFill>
            <a:srgbClr val="00B05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endParaRPr lang="en-US"/>
          </a:p>
        </p:txBody>
      </p:sp>
      <p:sp>
        <p:nvSpPr>
          <p:cNvPr id="218" name="Rectangle 217"/>
          <p:cNvSpPr/>
          <p:nvPr/>
        </p:nvSpPr>
        <p:spPr>
          <a:xfrm>
            <a:off x="1389869" y="1778489"/>
            <a:ext cx="128016" cy="1097280"/>
          </a:xfrm>
          <a:prstGeom prst="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endParaRPr lang="en-US"/>
          </a:p>
        </p:txBody>
      </p:sp>
      <p:sp>
        <p:nvSpPr>
          <p:cNvPr id="219" name="Rectangle 218"/>
          <p:cNvSpPr/>
          <p:nvPr/>
        </p:nvSpPr>
        <p:spPr>
          <a:xfrm>
            <a:off x="1559592" y="1967799"/>
            <a:ext cx="128016" cy="914400"/>
          </a:xfrm>
          <a:prstGeom prst="rect">
            <a:avLst/>
          </a:prstGeom>
          <a:solidFill>
            <a:srgbClr val="00B05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endParaRPr lang="en-US"/>
          </a:p>
        </p:txBody>
      </p:sp>
      <p:sp>
        <p:nvSpPr>
          <p:cNvPr id="220" name="Rectangle 219"/>
          <p:cNvSpPr/>
          <p:nvPr/>
        </p:nvSpPr>
        <p:spPr>
          <a:xfrm>
            <a:off x="1692688" y="1787789"/>
            <a:ext cx="128016" cy="1097280"/>
          </a:xfrm>
          <a:prstGeom prst="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endParaRPr lang="en-US"/>
          </a:p>
        </p:txBody>
      </p:sp>
      <p:sp>
        <p:nvSpPr>
          <p:cNvPr id="221" name="Rectangle 220"/>
          <p:cNvSpPr/>
          <p:nvPr/>
        </p:nvSpPr>
        <p:spPr>
          <a:xfrm>
            <a:off x="1866659" y="1964670"/>
            <a:ext cx="128016" cy="914400"/>
          </a:xfrm>
          <a:prstGeom prst="rect">
            <a:avLst/>
          </a:prstGeom>
          <a:solidFill>
            <a:srgbClr val="00B05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endParaRPr lang="en-US"/>
          </a:p>
        </p:txBody>
      </p:sp>
      <p:sp>
        <p:nvSpPr>
          <p:cNvPr id="222" name="Rectangle 221"/>
          <p:cNvSpPr/>
          <p:nvPr/>
        </p:nvSpPr>
        <p:spPr>
          <a:xfrm>
            <a:off x="2008381" y="1784660"/>
            <a:ext cx="128016" cy="1097280"/>
          </a:xfrm>
          <a:prstGeom prst="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endParaRPr lang="en-US"/>
          </a:p>
        </p:txBody>
      </p:sp>
      <p:sp>
        <p:nvSpPr>
          <p:cNvPr id="223" name="Rectangle 222"/>
          <p:cNvSpPr/>
          <p:nvPr/>
        </p:nvSpPr>
        <p:spPr>
          <a:xfrm>
            <a:off x="2188468" y="1968611"/>
            <a:ext cx="128016" cy="914400"/>
          </a:xfrm>
          <a:prstGeom prst="rect">
            <a:avLst/>
          </a:prstGeom>
          <a:solidFill>
            <a:srgbClr val="00B05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endParaRPr lang="en-US"/>
          </a:p>
        </p:txBody>
      </p:sp>
      <p:sp>
        <p:nvSpPr>
          <p:cNvPr id="224" name="Rectangle 223"/>
          <p:cNvSpPr/>
          <p:nvPr/>
        </p:nvSpPr>
        <p:spPr>
          <a:xfrm>
            <a:off x="2330190" y="1788601"/>
            <a:ext cx="128016" cy="1097280"/>
          </a:xfrm>
          <a:prstGeom prst="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endParaRPr lang="en-US"/>
          </a:p>
        </p:txBody>
      </p:sp>
      <p:sp>
        <p:nvSpPr>
          <p:cNvPr id="225" name="Rectangle 224"/>
          <p:cNvSpPr/>
          <p:nvPr/>
        </p:nvSpPr>
        <p:spPr>
          <a:xfrm>
            <a:off x="2495535" y="1965482"/>
            <a:ext cx="128016" cy="914400"/>
          </a:xfrm>
          <a:prstGeom prst="rect">
            <a:avLst/>
          </a:prstGeom>
          <a:solidFill>
            <a:srgbClr val="00B05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endParaRPr lang="en-US"/>
          </a:p>
        </p:txBody>
      </p:sp>
      <p:sp>
        <p:nvSpPr>
          <p:cNvPr id="226" name="Rectangle 225"/>
          <p:cNvSpPr/>
          <p:nvPr/>
        </p:nvSpPr>
        <p:spPr>
          <a:xfrm>
            <a:off x="2628631" y="1785472"/>
            <a:ext cx="128016" cy="1097280"/>
          </a:xfrm>
          <a:prstGeom prst="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endParaRPr lang="en-US"/>
          </a:p>
        </p:txBody>
      </p:sp>
      <p:sp>
        <p:nvSpPr>
          <p:cNvPr id="227" name="Rectangle 226"/>
          <p:cNvSpPr/>
          <p:nvPr/>
        </p:nvSpPr>
        <p:spPr>
          <a:xfrm>
            <a:off x="2806980" y="1966156"/>
            <a:ext cx="128016" cy="914400"/>
          </a:xfrm>
          <a:prstGeom prst="rect">
            <a:avLst/>
          </a:prstGeom>
          <a:solidFill>
            <a:srgbClr val="00B05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endParaRPr lang="en-US"/>
          </a:p>
        </p:txBody>
      </p:sp>
      <p:sp>
        <p:nvSpPr>
          <p:cNvPr id="228" name="Rectangle 227"/>
          <p:cNvSpPr/>
          <p:nvPr/>
        </p:nvSpPr>
        <p:spPr>
          <a:xfrm>
            <a:off x="2940076" y="1786146"/>
            <a:ext cx="128016" cy="1097280"/>
          </a:xfrm>
          <a:prstGeom prst="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endParaRPr lang="en-US"/>
          </a:p>
        </p:txBody>
      </p:sp>
      <p:sp>
        <p:nvSpPr>
          <p:cNvPr id="229" name="Rectangle 228"/>
          <p:cNvSpPr/>
          <p:nvPr/>
        </p:nvSpPr>
        <p:spPr>
          <a:xfrm>
            <a:off x="3114047" y="1971653"/>
            <a:ext cx="128016" cy="914400"/>
          </a:xfrm>
          <a:prstGeom prst="rect">
            <a:avLst/>
          </a:prstGeom>
          <a:solidFill>
            <a:srgbClr val="00B05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endParaRPr lang="en-US"/>
          </a:p>
        </p:txBody>
      </p:sp>
      <p:sp>
        <p:nvSpPr>
          <p:cNvPr id="230" name="Rectangle 229"/>
          <p:cNvSpPr/>
          <p:nvPr/>
        </p:nvSpPr>
        <p:spPr>
          <a:xfrm>
            <a:off x="3247143" y="1783017"/>
            <a:ext cx="128016" cy="1097280"/>
          </a:xfrm>
          <a:prstGeom prst="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endParaRPr lang="en-US"/>
          </a:p>
        </p:txBody>
      </p:sp>
      <p:sp>
        <p:nvSpPr>
          <p:cNvPr id="231" name="Rectangle 230"/>
          <p:cNvSpPr/>
          <p:nvPr/>
        </p:nvSpPr>
        <p:spPr>
          <a:xfrm>
            <a:off x="3430736" y="1968611"/>
            <a:ext cx="128016" cy="914400"/>
          </a:xfrm>
          <a:prstGeom prst="rect">
            <a:avLst/>
          </a:prstGeom>
          <a:solidFill>
            <a:srgbClr val="00B05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endParaRPr lang="en-US"/>
          </a:p>
        </p:txBody>
      </p:sp>
      <p:sp>
        <p:nvSpPr>
          <p:cNvPr id="232" name="Rectangle 231"/>
          <p:cNvSpPr/>
          <p:nvPr/>
        </p:nvSpPr>
        <p:spPr>
          <a:xfrm>
            <a:off x="3572458" y="1788601"/>
            <a:ext cx="128016" cy="1097280"/>
          </a:xfrm>
          <a:prstGeom prst="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endParaRPr lang="en-US"/>
          </a:p>
        </p:txBody>
      </p:sp>
      <p:sp>
        <p:nvSpPr>
          <p:cNvPr id="233" name="Rectangle 232"/>
          <p:cNvSpPr/>
          <p:nvPr/>
        </p:nvSpPr>
        <p:spPr>
          <a:xfrm>
            <a:off x="3746429" y="1965482"/>
            <a:ext cx="128016" cy="914400"/>
          </a:xfrm>
          <a:prstGeom prst="rect">
            <a:avLst/>
          </a:prstGeom>
          <a:solidFill>
            <a:srgbClr val="00B05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endParaRPr lang="en-US"/>
          </a:p>
        </p:txBody>
      </p:sp>
      <p:sp>
        <p:nvSpPr>
          <p:cNvPr id="234" name="Rectangle 233"/>
          <p:cNvSpPr/>
          <p:nvPr/>
        </p:nvSpPr>
        <p:spPr>
          <a:xfrm>
            <a:off x="3879525" y="1785472"/>
            <a:ext cx="128016" cy="1097280"/>
          </a:xfrm>
          <a:prstGeom prst="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endParaRPr lang="en-US"/>
          </a:p>
        </p:txBody>
      </p:sp>
      <p:sp>
        <p:nvSpPr>
          <p:cNvPr id="235" name="Rectangle 234"/>
          <p:cNvSpPr/>
          <p:nvPr/>
        </p:nvSpPr>
        <p:spPr>
          <a:xfrm>
            <a:off x="4066500" y="1966156"/>
            <a:ext cx="128016" cy="914400"/>
          </a:xfrm>
          <a:prstGeom prst="rect">
            <a:avLst/>
          </a:prstGeom>
          <a:solidFill>
            <a:srgbClr val="00B05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endParaRPr lang="en-US"/>
          </a:p>
        </p:txBody>
      </p:sp>
      <p:sp>
        <p:nvSpPr>
          <p:cNvPr id="236" name="Rectangle 235"/>
          <p:cNvSpPr/>
          <p:nvPr/>
        </p:nvSpPr>
        <p:spPr>
          <a:xfrm>
            <a:off x="4208222" y="1786146"/>
            <a:ext cx="128016" cy="1097280"/>
          </a:xfrm>
          <a:prstGeom prst="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endParaRPr lang="en-US"/>
          </a:p>
        </p:txBody>
      </p:sp>
      <p:sp>
        <p:nvSpPr>
          <p:cNvPr id="237" name="Rectangle 236"/>
          <p:cNvSpPr/>
          <p:nvPr/>
        </p:nvSpPr>
        <p:spPr>
          <a:xfrm>
            <a:off x="4390819" y="1971653"/>
            <a:ext cx="128016" cy="914400"/>
          </a:xfrm>
          <a:prstGeom prst="rect">
            <a:avLst/>
          </a:prstGeom>
          <a:solidFill>
            <a:srgbClr val="00B05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endParaRPr lang="en-US"/>
          </a:p>
        </p:txBody>
      </p:sp>
      <p:sp>
        <p:nvSpPr>
          <p:cNvPr id="238" name="Rectangle 237"/>
          <p:cNvSpPr/>
          <p:nvPr/>
        </p:nvSpPr>
        <p:spPr>
          <a:xfrm>
            <a:off x="4523915" y="1783017"/>
            <a:ext cx="128016" cy="1097280"/>
          </a:xfrm>
          <a:prstGeom prst="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endParaRPr lang="en-US"/>
          </a:p>
        </p:txBody>
      </p:sp>
      <p:cxnSp>
        <p:nvCxnSpPr>
          <p:cNvPr id="126" name="Straight Connector 125"/>
          <p:cNvCxnSpPr/>
          <p:nvPr/>
        </p:nvCxnSpPr>
        <p:spPr>
          <a:xfrm>
            <a:off x="720282" y="2883699"/>
            <a:ext cx="4602947" cy="85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5" name="Rectangle 244"/>
          <p:cNvSpPr/>
          <p:nvPr/>
        </p:nvSpPr>
        <p:spPr>
          <a:xfrm>
            <a:off x="5019037" y="1961413"/>
            <a:ext cx="128016" cy="914400"/>
          </a:xfrm>
          <a:prstGeom prst="rect">
            <a:avLst/>
          </a:prstGeom>
          <a:solidFill>
            <a:srgbClr val="00B05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endParaRPr lang="en-US"/>
          </a:p>
        </p:txBody>
      </p:sp>
      <p:sp>
        <p:nvSpPr>
          <p:cNvPr id="246" name="Rectangle 245"/>
          <p:cNvSpPr/>
          <p:nvPr/>
        </p:nvSpPr>
        <p:spPr>
          <a:xfrm>
            <a:off x="5143507" y="1789318"/>
            <a:ext cx="128016" cy="1097280"/>
          </a:xfrm>
          <a:prstGeom prst="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endParaRPr lang="en-US"/>
          </a:p>
        </p:txBody>
      </p:sp>
      <p:cxnSp>
        <p:nvCxnSpPr>
          <p:cNvPr id="209" name="Straight Connector 208"/>
          <p:cNvCxnSpPr/>
          <p:nvPr/>
        </p:nvCxnSpPr>
        <p:spPr>
          <a:xfrm flipV="1">
            <a:off x="737842" y="1956579"/>
            <a:ext cx="4542307" cy="7693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7" name="Rectangle 246"/>
          <p:cNvSpPr/>
          <p:nvPr/>
        </p:nvSpPr>
        <p:spPr>
          <a:xfrm>
            <a:off x="4705962" y="1957588"/>
            <a:ext cx="128016" cy="914400"/>
          </a:xfrm>
          <a:prstGeom prst="rect">
            <a:avLst/>
          </a:prstGeom>
          <a:solidFill>
            <a:srgbClr val="00B05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endParaRPr lang="en-US"/>
          </a:p>
        </p:txBody>
      </p:sp>
      <p:sp>
        <p:nvSpPr>
          <p:cNvPr id="248" name="Rectangle 247"/>
          <p:cNvSpPr/>
          <p:nvPr/>
        </p:nvSpPr>
        <p:spPr>
          <a:xfrm>
            <a:off x="4839058" y="1777578"/>
            <a:ext cx="128016" cy="1097280"/>
          </a:xfrm>
          <a:prstGeom prst="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endParaRPr lang="en-US"/>
          </a:p>
        </p:txBody>
      </p:sp>
      <p:sp>
        <p:nvSpPr>
          <p:cNvPr id="194" name="TextBox 193"/>
          <p:cNvSpPr txBox="1"/>
          <p:nvPr/>
        </p:nvSpPr>
        <p:spPr>
          <a:xfrm>
            <a:off x="43140" y="16901"/>
            <a:ext cx="97174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>
                <a:latin typeface="Arial" panose="020B0604020202020204" pitchFamily="34" charset="0"/>
                <a:cs typeface="Arial" panose="020B0604020202020204" pitchFamily="34" charset="0"/>
              </a:rPr>
              <a:t>Fig. </a:t>
            </a:r>
            <a:r>
              <a:rPr lang="en-US" sz="1600" b="1" smtClean="0">
                <a:latin typeface="Arial" panose="020B0604020202020204" pitchFamily="34" charset="0"/>
                <a:cs typeface="Arial" panose="020B0604020202020204" pitchFamily="34" charset="0"/>
              </a:rPr>
              <a:t>S12</a:t>
            </a:r>
            <a:endParaRPr lang="en-US" sz="1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60" name="Chart 59">
            <a:extLst>
              <a:ext uri="{FF2B5EF4-FFF2-40B4-BE49-F238E27FC236}">
                <a16:creationId xmlns:a16="http://schemas.microsoft.com/office/drawing/2014/main" id="{A2A201D7-732B-41B6-8C9A-1F9635B089E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94745347"/>
              </p:ext>
            </p:extLst>
          </p:nvPr>
        </p:nvGraphicFramePr>
        <p:xfrm>
          <a:off x="-1038425" y="3560970"/>
          <a:ext cx="7374036" cy="345343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1" name="Rectangle 60"/>
          <p:cNvSpPr/>
          <p:nvPr/>
        </p:nvSpPr>
        <p:spPr>
          <a:xfrm>
            <a:off x="902152" y="3958223"/>
            <a:ext cx="158101" cy="163653"/>
          </a:xfrm>
          <a:prstGeom prst="rect">
            <a:avLst/>
          </a:prstGeom>
          <a:solidFill>
            <a:srgbClr val="00B05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/>
          </a:p>
        </p:txBody>
      </p:sp>
      <p:sp>
        <p:nvSpPr>
          <p:cNvPr id="62" name="Rectangle 61"/>
          <p:cNvSpPr/>
          <p:nvPr/>
        </p:nvSpPr>
        <p:spPr>
          <a:xfrm>
            <a:off x="1056182" y="4194963"/>
            <a:ext cx="2680542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B3Z CTLs treated with proteasome activator</a:t>
            </a:r>
          </a:p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followed by co-culture with EG.7-Ova</a:t>
            </a:r>
            <a:endParaRPr lang="en-US" sz="1000"/>
          </a:p>
        </p:txBody>
      </p:sp>
      <p:sp>
        <p:nvSpPr>
          <p:cNvPr id="63" name="TextBox 62"/>
          <p:cNvSpPr txBox="1"/>
          <p:nvPr/>
        </p:nvSpPr>
        <p:spPr>
          <a:xfrm>
            <a:off x="1060253" y="3910826"/>
            <a:ext cx="10438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EG.7-Ova cells</a:t>
            </a:r>
          </a:p>
        </p:txBody>
      </p:sp>
      <p:sp>
        <p:nvSpPr>
          <p:cNvPr id="64" name="Rectangle 63"/>
          <p:cNvSpPr/>
          <p:nvPr/>
        </p:nvSpPr>
        <p:spPr>
          <a:xfrm>
            <a:off x="903092" y="4243102"/>
            <a:ext cx="164592" cy="164592"/>
          </a:xfrm>
          <a:prstGeom prst="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/>
          </a:p>
        </p:txBody>
      </p:sp>
      <p:sp>
        <p:nvSpPr>
          <p:cNvPr id="65" name="TextBox 64"/>
          <p:cNvSpPr txBox="1"/>
          <p:nvPr/>
        </p:nvSpPr>
        <p:spPr>
          <a:xfrm>
            <a:off x="-3951" y="195639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6" name="TextBox 65"/>
          <p:cNvSpPr txBox="1"/>
          <p:nvPr/>
        </p:nvSpPr>
        <p:spPr>
          <a:xfrm>
            <a:off x="43140" y="3479680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aphicFrame>
        <p:nvGraphicFramePr>
          <p:cNvPr id="67" name="Chart 66">
            <a:extLst>
              <a:ext uri="{FF2B5EF4-FFF2-40B4-BE49-F238E27FC236}">
                <a16:creationId xmlns:a16="http://schemas.microsoft.com/office/drawing/2014/main" id="{E2BA9EAD-B8AF-4D44-9845-E1544530CAA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88219741"/>
              </p:ext>
            </p:extLst>
          </p:nvPr>
        </p:nvGraphicFramePr>
        <p:xfrm>
          <a:off x="5332274" y="-53929"/>
          <a:ext cx="3531657" cy="344118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9" name="TextBox 68"/>
          <p:cNvSpPr txBox="1"/>
          <p:nvPr/>
        </p:nvSpPr>
        <p:spPr>
          <a:xfrm>
            <a:off x="5316534" y="149666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aphicFrame>
        <p:nvGraphicFramePr>
          <p:cNvPr id="70" name="Chart 69">
            <a:extLst>
              <a:ext uri="{FF2B5EF4-FFF2-40B4-BE49-F238E27FC236}">
                <a16:creationId xmlns:a16="http://schemas.microsoft.com/office/drawing/2014/main" id="{2A1705C9-6430-4066-80F2-5C4DC61BE21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78076365"/>
              </p:ext>
            </p:extLst>
          </p:nvPr>
        </p:nvGraphicFramePr>
        <p:xfrm>
          <a:off x="8419535" y="16901"/>
          <a:ext cx="3553929" cy="344118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71" name="TextBox 70"/>
          <p:cNvSpPr txBox="1"/>
          <p:nvPr/>
        </p:nvSpPr>
        <p:spPr>
          <a:xfrm>
            <a:off x="8244769" y="166084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graphicFrame>
        <p:nvGraphicFramePr>
          <p:cNvPr id="79" name="Chart 78">
            <a:extLst>
              <a:ext uri="{FF2B5EF4-FFF2-40B4-BE49-F238E27FC236}">
                <a16:creationId xmlns:a16="http://schemas.microsoft.com/office/drawing/2014/main" id="{7CC95E62-5C90-B220-38C7-9AB8C1C335F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75439829"/>
              </p:ext>
            </p:extLst>
          </p:nvPr>
        </p:nvGraphicFramePr>
        <p:xfrm>
          <a:off x="6226675" y="3260314"/>
          <a:ext cx="2804521" cy="344118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80" name="TextBox 79"/>
          <p:cNvSpPr txBox="1"/>
          <p:nvPr/>
        </p:nvSpPr>
        <p:spPr>
          <a:xfrm>
            <a:off x="6058371" y="3471783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2" name="Rectangle 1"/>
          <p:cNvSpPr/>
          <p:nvPr/>
        </p:nvSpPr>
        <p:spPr>
          <a:xfrm>
            <a:off x="8731460" y="3387258"/>
            <a:ext cx="3337705" cy="249299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>
                <a:solidFill>
                  <a:srgbClr val="C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Fig. S12. a. </a:t>
            </a:r>
            <a:r>
              <a:rPr lang="en-US" sz="1200">
                <a:latin typeface="Times New Roman" panose="02020603050405020304" pitchFamily="18" charset="0"/>
                <a:ea typeface="Times New Roman" panose="02020603050405020304" pitchFamily="18" charset="0"/>
              </a:rPr>
              <a:t>Effect of</a:t>
            </a:r>
            <a:r>
              <a:rPr lang="en-US" sz="12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the top pharmacologics alone on E.G7-Ova cell viability as measured by LDH release into the culture medium (green). Also shown is the effect of pre-treating the B3Z cells with the pharmacologics then co-culturing with E.G7-Ova cells (red). </a:t>
            </a:r>
            <a:r>
              <a:rPr lang="en-US" sz="1200" b="1">
                <a:solidFill>
                  <a:srgbClr val="C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b. </a:t>
            </a:r>
            <a:r>
              <a:rPr lang="en-US" sz="12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Effect of </a:t>
            </a:r>
            <a:r>
              <a:rPr lang="en-US" sz="120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pre-treatment </a:t>
            </a:r>
            <a:r>
              <a:rPr lang="en-US" sz="12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of B3Z cells with pharmacologics followed by co-culture with E.G7-Ova cells. Cell viability was measured by annexin-V</a:t>
            </a:r>
            <a:r>
              <a:rPr lang="en-US" sz="1200" baseline="300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+</a:t>
            </a:r>
            <a:r>
              <a:rPr lang="en-US" sz="12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staining as above. </a:t>
            </a:r>
            <a:r>
              <a:rPr lang="en-US" sz="1200" b="1">
                <a:solidFill>
                  <a:srgbClr val="C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c</a:t>
            </a:r>
            <a:r>
              <a:rPr lang="en-US" sz="12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. </a:t>
            </a:r>
            <a:r>
              <a:rPr lang="en-US" sz="1200">
                <a:latin typeface="Times New Roman" panose="02020603050405020304" pitchFamily="18" charset="0"/>
                <a:ea typeface="Times New Roman" panose="02020603050405020304" pitchFamily="18" charset="0"/>
              </a:rPr>
              <a:t>Effect of</a:t>
            </a:r>
            <a:r>
              <a:rPr lang="en-US" sz="12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HDAC6 inhibitors on E.G7-Ova viability. </a:t>
            </a:r>
            <a:r>
              <a:rPr lang="en-US" sz="1200" b="1">
                <a:solidFill>
                  <a:srgbClr val="C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d</a:t>
            </a:r>
            <a:r>
              <a:rPr lang="en-US" sz="12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. </a:t>
            </a:r>
            <a:r>
              <a:rPr lang="en-US" sz="1200">
                <a:latin typeface="Times New Roman" panose="02020603050405020304" pitchFamily="18" charset="0"/>
                <a:ea typeface="Times New Roman" panose="02020603050405020304" pitchFamily="18" charset="0"/>
              </a:rPr>
              <a:t>Effect of</a:t>
            </a:r>
            <a:r>
              <a:rPr lang="en-US" sz="12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HDAC6 inhibitors on B3Z viability. </a:t>
            </a:r>
            <a:endParaRPr lang="en-US" sz="120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r>
              <a:rPr lang="en-US" sz="1200" b="1">
                <a:solidFill>
                  <a:srgbClr val="C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e</a:t>
            </a:r>
            <a:r>
              <a:rPr lang="en-US" sz="12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. </a:t>
            </a:r>
            <a:r>
              <a:rPr lang="en-US" sz="1200">
                <a:latin typeface="Times New Roman" panose="02020603050405020304" pitchFamily="18" charset="0"/>
                <a:ea typeface="Times New Roman" panose="02020603050405020304" pitchFamily="18" charset="0"/>
              </a:rPr>
              <a:t>Effect of</a:t>
            </a:r>
            <a:r>
              <a:rPr lang="en-US" sz="12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HDAC6 inhibitors on E.G7-Ova viability after co-culture with B3Z cells at E:T 2:1. </a:t>
            </a:r>
            <a:endParaRPr lang="en-US" sz="120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783317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6394</TotalTime>
  <Words>212</Words>
  <Application>Microsoft Office PowerPoint</Application>
  <PresentationFormat>Widescreen</PresentationFormat>
  <Paragraphs>3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UHH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riscoll, James Joseph</dc:creator>
  <cp:lastModifiedBy>Driscoll, James Joseph</cp:lastModifiedBy>
  <cp:revision>100</cp:revision>
  <cp:lastPrinted>2024-03-02T18:31:01Z</cp:lastPrinted>
  <dcterms:created xsi:type="dcterms:W3CDTF">2022-08-15T18:48:13Z</dcterms:created>
  <dcterms:modified xsi:type="dcterms:W3CDTF">2024-05-03T22:08:27Z</dcterms:modified>
</cp:coreProperties>
</file>